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9326563" cy="42973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42" autoAdjust="0"/>
    <p:restoredTop sz="94660"/>
  </p:normalViewPr>
  <p:slideViewPr>
    <p:cSldViewPr snapToGrid="0">
      <p:cViewPr varScale="1">
        <p:scale>
          <a:sx n="78" d="100"/>
          <a:sy n="78" d="100"/>
        </p:scale>
        <p:origin x="77" y="1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GMWWHI.ORG\Global%20Drives\Users\ipierce\Apple%20Tree%20Dental\ATD%202019%20Paper\Tables%20and%20Figures\April%2026\Additional%20File%202.%20Dentition%20by%20Age%20Group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cap="all" spc="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400" b="1" kern="1200" cap="none" spc="0" baseline="0" dirty="0"/>
              <a:t>Supporting Information 1. Dentition by Age Group and Venue</a:t>
            </a:r>
          </a:p>
        </c:rich>
      </c:tx>
      <c:layout>
        <c:manualLayout>
          <c:xMode val="edge"/>
          <c:yMode val="edge"/>
          <c:x val="0.26078691552444827"/>
          <c:y val="2.777777777777777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cap="all" spc="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[Additional File 2. Dentition by Age Group.xlsx]Sup Fig 1. Dentition by Age Gp'!$A$3</c:f>
              <c:strCache>
                <c:ptCount val="1"/>
                <c:pt idx="0">
                  <c:v>Functional (20+ teeth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multiLvlStrRef>
              <c:f>'[Additional File 2. Dentition by Age Group.xlsx]Sup Fig 1. Dentition by Age Gp'!$C$1:$K$2</c:f>
              <c:multiLvlStrCache>
                <c:ptCount val="8"/>
                <c:lvl>
                  <c:pt idx="0">
                    <c:v>Age 55-64</c:v>
                  </c:pt>
                  <c:pt idx="1">
                    <c:v>Age 65 -74</c:v>
                  </c:pt>
                  <c:pt idx="2">
                    <c:v>Age 75-84</c:v>
                  </c:pt>
                  <c:pt idx="3">
                    <c:v>Age 85+</c:v>
                  </c:pt>
                  <c:pt idx="4">
                    <c:v>Age 55-64</c:v>
                  </c:pt>
                  <c:pt idx="5">
                    <c:v>Age 65 -74</c:v>
                  </c:pt>
                  <c:pt idx="6">
                    <c:v>Age 75-84</c:v>
                  </c:pt>
                  <c:pt idx="7">
                    <c:v>Age 85+</c:v>
                  </c:pt>
                </c:lvl>
                <c:lvl>
                  <c:pt idx="0">
                    <c:v>Outpatient Clinic (n = 503)</c:v>
                  </c:pt>
                  <c:pt idx="4">
                    <c:v>Long Term Care (n = 656)</c:v>
                  </c:pt>
                </c:lvl>
              </c:multiLvlStrCache>
              <c:extLst/>
            </c:multiLvlStrRef>
          </c:cat>
          <c:val>
            <c:numRef>
              <c:f>'[Additional File 2. Dentition by Age Group.xlsx]Sup Fig 1. Dentition by Age Gp'!$C$3:$K$3</c:f>
              <c:numCache>
                <c:formatCode>0%</c:formatCode>
                <c:ptCount val="8"/>
                <c:pt idx="0">
                  <c:v>0.87</c:v>
                </c:pt>
                <c:pt idx="1">
                  <c:v>0.81</c:v>
                </c:pt>
                <c:pt idx="2">
                  <c:v>0.64</c:v>
                </c:pt>
                <c:pt idx="3">
                  <c:v>0.79</c:v>
                </c:pt>
                <c:pt idx="4">
                  <c:v>0.64</c:v>
                </c:pt>
                <c:pt idx="5">
                  <c:v>0.62</c:v>
                </c:pt>
                <c:pt idx="6">
                  <c:v>0.65</c:v>
                </c:pt>
                <c:pt idx="7">
                  <c:v>0.6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1C88-487A-9089-6A656C37CBE0}"/>
            </c:ext>
          </c:extLst>
        </c:ser>
        <c:ser>
          <c:idx val="1"/>
          <c:order val="1"/>
          <c:tx>
            <c:strRef>
              <c:f>'[Additional File 2. Dentition by Age Group.xlsx]Sup Fig 1. Dentition by Age Gp'!$A$4</c:f>
              <c:strCache>
                <c:ptCount val="1"/>
                <c:pt idx="0">
                  <c:v>Impaired (9-19 teeth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multiLvlStrRef>
              <c:f>'[Additional File 2. Dentition by Age Group.xlsx]Sup Fig 1. Dentition by Age Gp'!$C$1:$K$2</c:f>
              <c:multiLvlStrCache>
                <c:ptCount val="8"/>
                <c:lvl>
                  <c:pt idx="0">
                    <c:v>Age 55-64</c:v>
                  </c:pt>
                  <c:pt idx="1">
                    <c:v>Age 65 -74</c:v>
                  </c:pt>
                  <c:pt idx="2">
                    <c:v>Age 75-84</c:v>
                  </c:pt>
                  <c:pt idx="3">
                    <c:v>Age 85+</c:v>
                  </c:pt>
                  <c:pt idx="4">
                    <c:v>Age 55-64</c:v>
                  </c:pt>
                  <c:pt idx="5">
                    <c:v>Age 65 -74</c:v>
                  </c:pt>
                  <c:pt idx="6">
                    <c:v>Age 75-84</c:v>
                  </c:pt>
                  <c:pt idx="7">
                    <c:v>Age 85+</c:v>
                  </c:pt>
                </c:lvl>
                <c:lvl>
                  <c:pt idx="0">
                    <c:v>Outpatient Clinic (n = 503)</c:v>
                  </c:pt>
                  <c:pt idx="4">
                    <c:v>Long Term Care (n = 656)</c:v>
                  </c:pt>
                </c:lvl>
              </c:multiLvlStrCache>
              <c:extLst/>
            </c:multiLvlStrRef>
          </c:cat>
          <c:val>
            <c:numRef>
              <c:f>'[Additional File 2. Dentition by Age Group.xlsx]Sup Fig 1. Dentition by Age Gp'!$C$4:$K$4</c:f>
              <c:numCache>
                <c:formatCode>0%</c:formatCode>
                <c:ptCount val="8"/>
                <c:pt idx="0">
                  <c:v>0.09</c:v>
                </c:pt>
                <c:pt idx="1">
                  <c:v>0.13</c:v>
                </c:pt>
                <c:pt idx="2">
                  <c:v>0.21</c:v>
                </c:pt>
                <c:pt idx="3">
                  <c:v>0.14000000000000001</c:v>
                </c:pt>
                <c:pt idx="4">
                  <c:v>0.15</c:v>
                </c:pt>
                <c:pt idx="5">
                  <c:v>0.14000000000000001</c:v>
                </c:pt>
                <c:pt idx="6">
                  <c:v>0.15</c:v>
                </c:pt>
                <c:pt idx="7">
                  <c:v>0.2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1C88-487A-9089-6A656C37CBE0}"/>
            </c:ext>
          </c:extLst>
        </c:ser>
        <c:ser>
          <c:idx val="2"/>
          <c:order val="2"/>
          <c:tx>
            <c:strRef>
              <c:f>'[Additional File 2. Dentition by Age Group.xlsx]Sup Fig 1. Dentition by Age Gp'!$A$5</c:f>
              <c:strCache>
                <c:ptCount val="1"/>
                <c:pt idx="0">
                  <c:v>Severe Tooth Loss (1-8 teeth)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multiLvlStrRef>
              <c:f>'[Additional File 2. Dentition by Age Group.xlsx]Sup Fig 1. Dentition by Age Gp'!$C$1:$K$2</c:f>
              <c:multiLvlStrCache>
                <c:ptCount val="8"/>
                <c:lvl>
                  <c:pt idx="0">
                    <c:v>Age 55-64</c:v>
                  </c:pt>
                  <c:pt idx="1">
                    <c:v>Age 65 -74</c:v>
                  </c:pt>
                  <c:pt idx="2">
                    <c:v>Age 75-84</c:v>
                  </c:pt>
                  <c:pt idx="3">
                    <c:v>Age 85+</c:v>
                  </c:pt>
                  <c:pt idx="4">
                    <c:v>Age 55-64</c:v>
                  </c:pt>
                  <c:pt idx="5">
                    <c:v>Age 65 -74</c:v>
                  </c:pt>
                  <c:pt idx="6">
                    <c:v>Age 75-84</c:v>
                  </c:pt>
                  <c:pt idx="7">
                    <c:v>Age 85+</c:v>
                  </c:pt>
                </c:lvl>
                <c:lvl>
                  <c:pt idx="0">
                    <c:v>Outpatient Clinic (n = 503)</c:v>
                  </c:pt>
                  <c:pt idx="4">
                    <c:v>Long Term Care (n = 656)</c:v>
                  </c:pt>
                </c:lvl>
              </c:multiLvlStrCache>
              <c:extLst/>
            </c:multiLvlStrRef>
          </c:cat>
          <c:val>
            <c:numRef>
              <c:f>'[Additional File 2. Dentition by Age Group.xlsx]Sup Fig 1. Dentition by Age Gp'!$C$5:$K$5</c:f>
              <c:numCache>
                <c:formatCode>0%</c:formatCode>
                <c:ptCount val="8"/>
                <c:pt idx="0">
                  <c:v>0.02</c:v>
                </c:pt>
                <c:pt idx="1">
                  <c:v>0.05</c:v>
                </c:pt>
                <c:pt idx="2">
                  <c:v>0.11</c:v>
                </c:pt>
                <c:pt idx="3">
                  <c:v>7.0000000000000007E-2</c:v>
                </c:pt>
                <c:pt idx="4">
                  <c:v>0.08</c:v>
                </c:pt>
                <c:pt idx="5">
                  <c:v>0.1</c:v>
                </c:pt>
                <c:pt idx="6">
                  <c:v>0.08</c:v>
                </c:pt>
                <c:pt idx="7">
                  <c:v>0.08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1C88-487A-9089-6A656C37CBE0}"/>
            </c:ext>
          </c:extLst>
        </c:ser>
        <c:ser>
          <c:idx val="3"/>
          <c:order val="3"/>
          <c:tx>
            <c:strRef>
              <c:f>'[Additional File 2. Dentition by Age Group.xlsx]Sup Fig 1. Dentition by Age Gp'!$A$6</c:f>
              <c:strCache>
                <c:ptCount val="1"/>
                <c:pt idx="0">
                  <c:v>Edentulous (0 teeth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multiLvlStrRef>
              <c:f>'[Additional File 2. Dentition by Age Group.xlsx]Sup Fig 1. Dentition by Age Gp'!$C$1:$K$2</c:f>
              <c:multiLvlStrCache>
                <c:ptCount val="8"/>
                <c:lvl>
                  <c:pt idx="0">
                    <c:v>Age 55-64</c:v>
                  </c:pt>
                  <c:pt idx="1">
                    <c:v>Age 65 -74</c:v>
                  </c:pt>
                  <c:pt idx="2">
                    <c:v>Age 75-84</c:v>
                  </c:pt>
                  <c:pt idx="3">
                    <c:v>Age 85+</c:v>
                  </c:pt>
                  <c:pt idx="4">
                    <c:v>Age 55-64</c:v>
                  </c:pt>
                  <c:pt idx="5">
                    <c:v>Age 65 -74</c:v>
                  </c:pt>
                  <c:pt idx="6">
                    <c:v>Age 75-84</c:v>
                  </c:pt>
                  <c:pt idx="7">
                    <c:v>Age 85+</c:v>
                  </c:pt>
                </c:lvl>
                <c:lvl>
                  <c:pt idx="0">
                    <c:v>Outpatient Clinic (n = 503)</c:v>
                  </c:pt>
                  <c:pt idx="4">
                    <c:v>Long Term Care (n = 656)</c:v>
                  </c:pt>
                </c:lvl>
              </c:multiLvlStrCache>
              <c:extLst/>
            </c:multiLvlStrRef>
          </c:cat>
          <c:val>
            <c:numRef>
              <c:f>'[Additional File 2. Dentition by Age Group.xlsx]Sup Fig 1. Dentition by Age Gp'!$C$6:$K$6</c:f>
              <c:numCache>
                <c:formatCode>0%</c:formatCode>
                <c:ptCount val="8"/>
                <c:pt idx="0">
                  <c:v>0.02</c:v>
                </c:pt>
                <c:pt idx="1">
                  <c:v>0.01</c:v>
                </c:pt>
                <c:pt idx="2">
                  <c:v>0.04</c:v>
                </c:pt>
                <c:pt idx="4">
                  <c:v>0.14000000000000001</c:v>
                </c:pt>
                <c:pt idx="5">
                  <c:v>0.14000000000000001</c:v>
                </c:pt>
                <c:pt idx="6">
                  <c:v>0.12</c:v>
                </c:pt>
                <c:pt idx="7">
                  <c:v>0.09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3-1C88-487A-9089-6A656C37CBE0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79"/>
        <c:overlap val="100"/>
        <c:axId val="443758472"/>
        <c:axId val="443759128"/>
      </c:barChart>
      <c:catAx>
        <c:axId val="44375847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200" b="0" i="0" u="none" strike="noStrike" kern="1200" cap="none" spc="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3759128"/>
        <c:crosses val="autoZero"/>
        <c:auto val="1"/>
        <c:lblAlgn val="ctr"/>
        <c:lblOffset val="100"/>
        <c:noMultiLvlLbl val="0"/>
      </c:catAx>
      <c:valAx>
        <c:axId val="443759128"/>
        <c:scaling>
          <c:orientation val="minMax"/>
        </c:scaling>
        <c:delete val="1"/>
        <c:axPos val="l"/>
        <c:numFmt formatCode="0%" sourceLinked="1"/>
        <c:majorTickMark val="none"/>
        <c:minorTickMark val="none"/>
        <c:tickLblPos val="nextTo"/>
        <c:crossAx val="4437584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8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defRPr sz="900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65821" y="703296"/>
            <a:ext cx="6994922" cy="1496119"/>
          </a:xfrm>
        </p:spPr>
        <p:txBody>
          <a:bodyPr anchor="b"/>
          <a:lstStyle>
            <a:lvl1pPr algn="ctr">
              <a:defRPr sz="37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21" y="2257111"/>
            <a:ext cx="6994922" cy="1037534"/>
          </a:xfrm>
        </p:spPr>
        <p:txBody>
          <a:bodyPr/>
          <a:lstStyle>
            <a:lvl1pPr marL="0" indent="0" algn="ctr">
              <a:buNone/>
              <a:defRPr sz="1504"/>
            </a:lvl1pPr>
            <a:lvl2pPr marL="286482" indent="0" algn="ctr">
              <a:buNone/>
              <a:defRPr sz="1253"/>
            </a:lvl2pPr>
            <a:lvl3pPr marL="572963" indent="0" algn="ctr">
              <a:buNone/>
              <a:defRPr sz="1128"/>
            </a:lvl3pPr>
            <a:lvl4pPr marL="859445" indent="0" algn="ctr">
              <a:buNone/>
              <a:defRPr sz="1003"/>
            </a:lvl4pPr>
            <a:lvl5pPr marL="1145926" indent="0" algn="ctr">
              <a:buNone/>
              <a:defRPr sz="1003"/>
            </a:lvl5pPr>
            <a:lvl6pPr marL="1432408" indent="0" algn="ctr">
              <a:buNone/>
              <a:defRPr sz="1003"/>
            </a:lvl6pPr>
            <a:lvl7pPr marL="1718889" indent="0" algn="ctr">
              <a:buNone/>
              <a:defRPr sz="1003"/>
            </a:lvl7pPr>
            <a:lvl8pPr marL="2005371" indent="0" algn="ctr">
              <a:buNone/>
              <a:defRPr sz="1003"/>
            </a:lvl8pPr>
            <a:lvl9pPr marL="2291852" indent="0" algn="ctr">
              <a:buNone/>
              <a:defRPr sz="100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AD35D-49FD-46C0-8315-17AA18EEDB73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FD7FB-62BC-49B0-B2E3-7AD7E69AC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94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AD35D-49FD-46C0-8315-17AA18EEDB73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FD7FB-62BC-49B0-B2E3-7AD7E69AC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02553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74322" y="228795"/>
            <a:ext cx="2011040" cy="36418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41201" y="228795"/>
            <a:ext cx="5916538" cy="36418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AD35D-49FD-46C0-8315-17AA18EEDB73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FD7FB-62BC-49B0-B2E3-7AD7E69AC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478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AD35D-49FD-46C0-8315-17AA18EEDB73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FD7FB-62BC-49B0-B2E3-7AD7E69AC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85109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6343" y="1071357"/>
            <a:ext cx="8044161" cy="1787583"/>
          </a:xfrm>
        </p:spPr>
        <p:txBody>
          <a:bodyPr anchor="b"/>
          <a:lstStyle>
            <a:lvl1pPr>
              <a:defRPr sz="37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6343" y="2875852"/>
            <a:ext cx="8044161" cy="940048"/>
          </a:xfrm>
        </p:spPr>
        <p:txBody>
          <a:bodyPr/>
          <a:lstStyle>
            <a:lvl1pPr marL="0" indent="0">
              <a:buNone/>
              <a:defRPr sz="1504">
                <a:solidFill>
                  <a:schemeClr val="tx1">
                    <a:tint val="75000"/>
                  </a:schemeClr>
                </a:solidFill>
              </a:defRPr>
            </a:lvl1pPr>
            <a:lvl2pPr marL="286482" indent="0">
              <a:buNone/>
              <a:defRPr sz="1253">
                <a:solidFill>
                  <a:schemeClr val="tx1">
                    <a:tint val="75000"/>
                  </a:schemeClr>
                </a:solidFill>
              </a:defRPr>
            </a:lvl2pPr>
            <a:lvl3pPr marL="572963" indent="0">
              <a:buNone/>
              <a:defRPr sz="1128">
                <a:solidFill>
                  <a:schemeClr val="tx1">
                    <a:tint val="75000"/>
                  </a:schemeClr>
                </a:solidFill>
              </a:defRPr>
            </a:lvl3pPr>
            <a:lvl4pPr marL="859445" indent="0">
              <a:buNone/>
              <a:defRPr sz="1003">
                <a:solidFill>
                  <a:schemeClr val="tx1">
                    <a:tint val="75000"/>
                  </a:schemeClr>
                </a:solidFill>
              </a:defRPr>
            </a:lvl4pPr>
            <a:lvl5pPr marL="1145926" indent="0">
              <a:buNone/>
              <a:defRPr sz="1003">
                <a:solidFill>
                  <a:schemeClr val="tx1">
                    <a:tint val="75000"/>
                  </a:schemeClr>
                </a:solidFill>
              </a:defRPr>
            </a:lvl5pPr>
            <a:lvl6pPr marL="1432408" indent="0">
              <a:buNone/>
              <a:defRPr sz="1003">
                <a:solidFill>
                  <a:schemeClr val="tx1">
                    <a:tint val="75000"/>
                  </a:schemeClr>
                </a:solidFill>
              </a:defRPr>
            </a:lvl6pPr>
            <a:lvl7pPr marL="1718889" indent="0">
              <a:buNone/>
              <a:defRPr sz="1003">
                <a:solidFill>
                  <a:schemeClr val="tx1">
                    <a:tint val="75000"/>
                  </a:schemeClr>
                </a:solidFill>
              </a:defRPr>
            </a:lvl7pPr>
            <a:lvl8pPr marL="2005371" indent="0">
              <a:buNone/>
              <a:defRPr sz="1003">
                <a:solidFill>
                  <a:schemeClr val="tx1">
                    <a:tint val="75000"/>
                  </a:schemeClr>
                </a:solidFill>
              </a:defRPr>
            </a:lvl8pPr>
            <a:lvl9pPr marL="2291852" indent="0">
              <a:buNone/>
              <a:defRPr sz="100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AD35D-49FD-46C0-8315-17AA18EEDB73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FD7FB-62BC-49B0-B2E3-7AD7E69AC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74457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41201" y="1143974"/>
            <a:ext cx="3963789" cy="272663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1573" y="1143974"/>
            <a:ext cx="3963789" cy="272663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AD35D-49FD-46C0-8315-17AA18EEDB73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FD7FB-62BC-49B0-B2E3-7AD7E69AC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9731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2416" y="228795"/>
            <a:ext cx="8044161" cy="8306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2416" y="1053451"/>
            <a:ext cx="3945573" cy="516280"/>
          </a:xfrm>
        </p:spPr>
        <p:txBody>
          <a:bodyPr anchor="b"/>
          <a:lstStyle>
            <a:lvl1pPr marL="0" indent="0">
              <a:buNone/>
              <a:defRPr sz="1504" b="1"/>
            </a:lvl1pPr>
            <a:lvl2pPr marL="286482" indent="0">
              <a:buNone/>
              <a:defRPr sz="1253" b="1"/>
            </a:lvl2pPr>
            <a:lvl3pPr marL="572963" indent="0">
              <a:buNone/>
              <a:defRPr sz="1128" b="1"/>
            </a:lvl3pPr>
            <a:lvl4pPr marL="859445" indent="0">
              <a:buNone/>
              <a:defRPr sz="1003" b="1"/>
            </a:lvl4pPr>
            <a:lvl5pPr marL="1145926" indent="0">
              <a:buNone/>
              <a:defRPr sz="1003" b="1"/>
            </a:lvl5pPr>
            <a:lvl6pPr marL="1432408" indent="0">
              <a:buNone/>
              <a:defRPr sz="1003" b="1"/>
            </a:lvl6pPr>
            <a:lvl7pPr marL="1718889" indent="0">
              <a:buNone/>
              <a:defRPr sz="1003" b="1"/>
            </a:lvl7pPr>
            <a:lvl8pPr marL="2005371" indent="0">
              <a:buNone/>
              <a:defRPr sz="1003" b="1"/>
            </a:lvl8pPr>
            <a:lvl9pPr marL="2291852" indent="0">
              <a:buNone/>
              <a:defRPr sz="100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2416" y="1569731"/>
            <a:ext cx="3945573" cy="2308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721573" y="1053451"/>
            <a:ext cx="3965004" cy="516280"/>
          </a:xfrm>
        </p:spPr>
        <p:txBody>
          <a:bodyPr anchor="b"/>
          <a:lstStyle>
            <a:lvl1pPr marL="0" indent="0">
              <a:buNone/>
              <a:defRPr sz="1504" b="1"/>
            </a:lvl1pPr>
            <a:lvl2pPr marL="286482" indent="0">
              <a:buNone/>
              <a:defRPr sz="1253" b="1"/>
            </a:lvl2pPr>
            <a:lvl3pPr marL="572963" indent="0">
              <a:buNone/>
              <a:defRPr sz="1128" b="1"/>
            </a:lvl3pPr>
            <a:lvl4pPr marL="859445" indent="0">
              <a:buNone/>
              <a:defRPr sz="1003" b="1"/>
            </a:lvl4pPr>
            <a:lvl5pPr marL="1145926" indent="0">
              <a:buNone/>
              <a:defRPr sz="1003" b="1"/>
            </a:lvl5pPr>
            <a:lvl6pPr marL="1432408" indent="0">
              <a:buNone/>
              <a:defRPr sz="1003" b="1"/>
            </a:lvl6pPr>
            <a:lvl7pPr marL="1718889" indent="0">
              <a:buNone/>
              <a:defRPr sz="1003" b="1"/>
            </a:lvl7pPr>
            <a:lvl8pPr marL="2005371" indent="0">
              <a:buNone/>
              <a:defRPr sz="1003" b="1"/>
            </a:lvl8pPr>
            <a:lvl9pPr marL="2291852" indent="0">
              <a:buNone/>
              <a:defRPr sz="100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721573" y="1569731"/>
            <a:ext cx="3965004" cy="2308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AD35D-49FD-46C0-8315-17AA18EEDB73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FD7FB-62BC-49B0-B2E3-7AD7E69AC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216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AD35D-49FD-46C0-8315-17AA18EEDB73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FD7FB-62BC-49B0-B2E3-7AD7E69AC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251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AD35D-49FD-46C0-8315-17AA18EEDB73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FD7FB-62BC-49B0-B2E3-7AD7E69AC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5154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2416" y="286491"/>
            <a:ext cx="3008059" cy="1002718"/>
          </a:xfrm>
        </p:spPr>
        <p:txBody>
          <a:bodyPr anchor="b"/>
          <a:lstStyle>
            <a:lvl1pPr>
              <a:defRPr sz="200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65004" y="618741"/>
            <a:ext cx="4721573" cy="3053913"/>
          </a:xfrm>
        </p:spPr>
        <p:txBody>
          <a:bodyPr/>
          <a:lstStyle>
            <a:lvl1pPr>
              <a:defRPr sz="2005"/>
            </a:lvl1pPr>
            <a:lvl2pPr>
              <a:defRPr sz="1754"/>
            </a:lvl2pPr>
            <a:lvl3pPr>
              <a:defRPr sz="1504"/>
            </a:lvl3pPr>
            <a:lvl4pPr>
              <a:defRPr sz="1253"/>
            </a:lvl4pPr>
            <a:lvl5pPr>
              <a:defRPr sz="1253"/>
            </a:lvl5pPr>
            <a:lvl6pPr>
              <a:defRPr sz="1253"/>
            </a:lvl6pPr>
            <a:lvl7pPr>
              <a:defRPr sz="1253"/>
            </a:lvl7pPr>
            <a:lvl8pPr>
              <a:defRPr sz="1253"/>
            </a:lvl8pPr>
            <a:lvl9pPr>
              <a:defRPr sz="1253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2416" y="1289209"/>
            <a:ext cx="3008059" cy="2388419"/>
          </a:xfrm>
        </p:spPr>
        <p:txBody>
          <a:bodyPr/>
          <a:lstStyle>
            <a:lvl1pPr marL="0" indent="0">
              <a:buNone/>
              <a:defRPr sz="1003"/>
            </a:lvl1pPr>
            <a:lvl2pPr marL="286482" indent="0">
              <a:buNone/>
              <a:defRPr sz="877"/>
            </a:lvl2pPr>
            <a:lvl3pPr marL="572963" indent="0">
              <a:buNone/>
              <a:defRPr sz="752"/>
            </a:lvl3pPr>
            <a:lvl4pPr marL="859445" indent="0">
              <a:buNone/>
              <a:defRPr sz="627"/>
            </a:lvl4pPr>
            <a:lvl5pPr marL="1145926" indent="0">
              <a:buNone/>
              <a:defRPr sz="627"/>
            </a:lvl5pPr>
            <a:lvl6pPr marL="1432408" indent="0">
              <a:buNone/>
              <a:defRPr sz="627"/>
            </a:lvl6pPr>
            <a:lvl7pPr marL="1718889" indent="0">
              <a:buNone/>
              <a:defRPr sz="627"/>
            </a:lvl7pPr>
            <a:lvl8pPr marL="2005371" indent="0">
              <a:buNone/>
              <a:defRPr sz="627"/>
            </a:lvl8pPr>
            <a:lvl9pPr marL="2291852" indent="0">
              <a:buNone/>
              <a:defRPr sz="62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AD35D-49FD-46C0-8315-17AA18EEDB73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FD7FB-62BC-49B0-B2E3-7AD7E69AC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8830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2416" y="286491"/>
            <a:ext cx="3008059" cy="1002718"/>
          </a:xfrm>
        </p:spPr>
        <p:txBody>
          <a:bodyPr anchor="b"/>
          <a:lstStyle>
            <a:lvl1pPr>
              <a:defRPr sz="200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965004" y="618741"/>
            <a:ext cx="4721573" cy="3053913"/>
          </a:xfrm>
        </p:spPr>
        <p:txBody>
          <a:bodyPr anchor="t"/>
          <a:lstStyle>
            <a:lvl1pPr marL="0" indent="0">
              <a:buNone/>
              <a:defRPr sz="2005"/>
            </a:lvl1pPr>
            <a:lvl2pPr marL="286482" indent="0">
              <a:buNone/>
              <a:defRPr sz="1754"/>
            </a:lvl2pPr>
            <a:lvl3pPr marL="572963" indent="0">
              <a:buNone/>
              <a:defRPr sz="1504"/>
            </a:lvl3pPr>
            <a:lvl4pPr marL="859445" indent="0">
              <a:buNone/>
              <a:defRPr sz="1253"/>
            </a:lvl4pPr>
            <a:lvl5pPr marL="1145926" indent="0">
              <a:buNone/>
              <a:defRPr sz="1253"/>
            </a:lvl5pPr>
            <a:lvl6pPr marL="1432408" indent="0">
              <a:buNone/>
              <a:defRPr sz="1253"/>
            </a:lvl6pPr>
            <a:lvl7pPr marL="1718889" indent="0">
              <a:buNone/>
              <a:defRPr sz="1253"/>
            </a:lvl7pPr>
            <a:lvl8pPr marL="2005371" indent="0">
              <a:buNone/>
              <a:defRPr sz="1253"/>
            </a:lvl8pPr>
            <a:lvl9pPr marL="2291852" indent="0">
              <a:buNone/>
              <a:defRPr sz="125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2416" y="1289209"/>
            <a:ext cx="3008059" cy="2388419"/>
          </a:xfrm>
        </p:spPr>
        <p:txBody>
          <a:bodyPr/>
          <a:lstStyle>
            <a:lvl1pPr marL="0" indent="0">
              <a:buNone/>
              <a:defRPr sz="1003"/>
            </a:lvl1pPr>
            <a:lvl2pPr marL="286482" indent="0">
              <a:buNone/>
              <a:defRPr sz="877"/>
            </a:lvl2pPr>
            <a:lvl3pPr marL="572963" indent="0">
              <a:buNone/>
              <a:defRPr sz="752"/>
            </a:lvl3pPr>
            <a:lvl4pPr marL="859445" indent="0">
              <a:buNone/>
              <a:defRPr sz="627"/>
            </a:lvl4pPr>
            <a:lvl5pPr marL="1145926" indent="0">
              <a:buNone/>
              <a:defRPr sz="627"/>
            </a:lvl5pPr>
            <a:lvl6pPr marL="1432408" indent="0">
              <a:buNone/>
              <a:defRPr sz="627"/>
            </a:lvl6pPr>
            <a:lvl7pPr marL="1718889" indent="0">
              <a:buNone/>
              <a:defRPr sz="627"/>
            </a:lvl7pPr>
            <a:lvl8pPr marL="2005371" indent="0">
              <a:buNone/>
              <a:defRPr sz="627"/>
            </a:lvl8pPr>
            <a:lvl9pPr marL="2291852" indent="0">
              <a:buNone/>
              <a:defRPr sz="62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AD35D-49FD-46C0-8315-17AA18EEDB73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FD7FB-62BC-49B0-B2E3-7AD7E69AC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301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41201" y="228795"/>
            <a:ext cx="8044161" cy="8306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1201" y="1143974"/>
            <a:ext cx="8044161" cy="272663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41201" y="3983019"/>
            <a:ext cx="2098477" cy="2287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9AD35D-49FD-46C0-8315-17AA18EEDB73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89424" y="3983019"/>
            <a:ext cx="3147715" cy="2287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86885" y="3983019"/>
            <a:ext cx="2098477" cy="2287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9FD7FB-62BC-49B0-B2E3-7AD7E69AC2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475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72963" rtl="0" eaLnBrk="1" latinLnBrk="0" hangingPunct="1">
        <a:lnSpc>
          <a:spcPct val="90000"/>
        </a:lnSpc>
        <a:spcBef>
          <a:spcPct val="0"/>
        </a:spcBef>
        <a:buNone/>
        <a:defRPr sz="275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3241" indent="-143241" algn="l" defTabSz="572963" rtl="0" eaLnBrk="1" latinLnBrk="0" hangingPunct="1">
        <a:lnSpc>
          <a:spcPct val="90000"/>
        </a:lnSpc>
        <a:spcBef>
          <a:spcPts val="627"/>
        </a:spcBef>
        <a:buFont typeface="Arial" panose="020B0604020202020204" pitchFamily="34" charset="0"/>
        <a:buChar char="•"/>
        <a:defRPr sz="1754" kern="1200">
          <a:solidFill>
            <a:schemeClr val="tx1"/>
          </a:solidFill>
          <a:latin typeface="+mn-lt"/>
          <a:ea typeface="+mn-ea"/>
          <a:cs typeface="+mn-cs"/>
        </a:defRPr>
      </a:lvl1pPr>
      <a:lvl2pPr marL="429722" indent="-143241" algn="l" defTabSz="572963" rtl="0" eaLnBrk="1" latinLnBrk="0" hangingPunct="1">
        <a:lnSpc>
          <a:spcPct val="90000"/>
        </a:lnSpc>
        <a:spcBef>
          <a:spcPts val="313"/>
        </a:spcBef>
        <a:buFont typeface="Arial" panose="020B0604020202020204" pitchFamily="34" charset="0"/>
        <a:buChar char="•"/>
        <a:defRPr sz="1504" kern="1200">
          <a:solidFill>
            <a:schemeClr val="tx1"/>
          </a:solidFill>
          <a:latin typeface="+mn-lt"/>
          <a:ea typeface="+mn-ea"/>
          <a:cs typeface="+mn-cs"/>
        </a:defRPr>
      </a:lvl2pPr>
      <a:lvl3pPr marL="716204" indent="-143241" algn="l" defTabSz="572963" rtl="0" eaLnBrk="1" latinLnBrk="0" hangingPunct="1">
        <a:lnSpc>
          <a:spcPct val="90000"/>
        </a:lnSpc>
        <a:spcBef>
          <a:spcPts val="313"/>
        </a:spcBef>
        <a:buFont typeface="Arial" panose="020B0604020202020204" pitchFamily="34" charset="0"/>
        <a:buChar char="•"/>
        <a:defRPr sz="1253" kern="1200">
          <a:solidFill>
            <a:schemeClr val="tx1"/>
          </a:solidFill>
          <a:latin typeface="+mn-lt"/>
          <a:ea typeface="+mn-ea"/>
          <a:cs typeface="+mn-cs"/>
        </a:defRPr>
      </a:lvl3pPr>
      <a:lvl4pPr marL="1002685" indent="-143241" algn="l" defTabSz="572963" rtl="0" eaLnBrk="1" latinLnBrk="0" hangingPunct="1">
        <a:lnSpc>
          <a:spcPct val="90000"/>
        </a:lnSpc>
        <a:spcBef>
          <a:spcPts val="313"/>
        </a:spcBef>
        <a:buFont typeface="Arial" panose="020B0604020202020204" pitchFamily="34" charset="0"/>
        <a:buChar char="•"/>
        <a:defRPr sz="1128" kern="1200">
          <a:solidFill>
            <a:schemeClr val="tx1"/>
          </a:solidFill>
          <a:latin typeface="+mn-lt"/>
          <a:ea typeface="+mn-ea"/>
          <a:cs typeface="+mn-cs"/>
        </a:defRPr>
      </a:lvl4pPr>
      <a:lvl5pPr marL="1289167" indent="-143241" algn="l" defTabSz="572963" rtl="0" eaLnBrk="1" latinLnBrk="0" hangingPunct="1">
        <a:lnSpc>
          <a:spcPct val="90000"/>
        </a:lnSpc>
        <a:spcBef>
          <a:spcPts val="313"/>
        </a:spcBef>
        <a:buFont typeface="Arial" panose="020B0604020202020204" pitchFamily="34" charset="0"/>
        <a:buChar char="•"/>
        <a:defRPr sz="1128" kern="1200">
          <a:solidFill>
            <a:schemeClr val="tx1"/>
          </a:solidFill>
          <a:latin typeface="+mn-lt"/>
          <a:ea typeface="+mn-ea"/>
          <a:cs typeface="+mn-cs"/>
        </a:defRPr>
      </a:lvl5pPr>
      <a:lvl6pPr marL="1575648" indent="-143241" algn="l" defTabSz="572963" rtl="0" eaLnBrk="1" latinLnBrk="0" hangingPunct="1">
        <a:lnSpc>
          <a:spcPct val="90000"/>
        </a:lnSpc>
        <a:spcBef>
          <a:spcPts val="313"/>
        </a:spcBef>
        <a:buFont typeface="Arial" panose="020B0604020202020204" pitchFamily="34" charset="0"/>
        <a:buChar char="•"/>
        <a:defRPr sz="1128" kern="1200">
          <a:solidFill>
            <a:schemeClr val="tx1"/>
          </a:solidFill>
          <a:latin typeface="+mn-lt"/>
          <a:ea typeface="+mn-ea"/>
          <a:cs typeface="+mn-cs"/>
        </a:defRPr>
      </a:lvl6pPr>
      <a:lvl7pPr marL="1862130" indent="-143241" algn="l" defTabSz="572963" rtl="0" eaLnBrk="1" latinLnBrk="0" hangingPunct="1">
        <a:lnSpc>
          <a:spcPct val="90000"/>
        </a:lnSpc>
        <a:spcBef>
          <a:spcPts val="313"/>
        </a:spcBef>
        <a:buFont typeface="Arial" panose="020B0604020202020204" pitchFamily="34" charset="0"/>
        <a:buChar char="•"/>
        <a:defRPr sz="1128" kern="1200">
          <a:solidFill>
            <a:schemeClr val="tx1"/>
          </a:solidFill>
          <a:latin typeface="+mn-lt"/>
          <a:ea typeface="+mn-ea"/>
          <a:cs typeface="+mn-cs"/>
        </a:defRPr>
      </a:lvl7pPr>
      <a:lvl8pPr marL="2148611" indent="-143241" algn="l" defTabSz="572963" rtl="0" eaLnBrk="1" latinLnBrk="0" hangingPunct="1">
        <a:lnSpc>
          <a:spcPct val="90000"/>
        </a:lnSpc>
        <a:spcBef>
          <a:spcPts val="313"/>
        </a:spcBef>
        <a:buFont typeface="Arial" panose="020B0604020202020204" pitchFamily="34" charset="0"/>
        <a:buChar char="•"/>
        <a:defRPr sz="1128" kern="1200">
          <a:solidFill>
            <a:schemeClr val="tx1"/>
          </a:solidFill>
          <a:latin typeface="+mn-lt"/>
          <a:ea typeface="+mn-ea"/>
          <a:cs typeface="+mn-cs"/>
        </a:defRPr>
      </a:lvl8pPr>
      <a:lvl9pPr marL="2435093" indent="-143241" algn="l" defTabSz="572963" rtl="0" eaLnBrk="1" latinLnBrk="0" hangingPunct="1">
        <a:lnSpc>
          <a:spcPct val="90000"/>
        </a:lnSpc>
        <a:spcBef>
          <a:spcPts val="313"/>
        </a:spcBef>
        <a:buFont typeface="Arial" panose="020B0604020202020204" pitchFamily="34" charset="0"/>
        <a:buChar char="•"/>
        <a:defRPr sz="112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72963" rtl="0" eaLnBrk="1" latinLnBrk="0" hangingPunct="1">
        <a:defRPr sz="1128" kern="1200">
          <a:solidFill>
            <a:schemeClr val="tx1"/>
          </a:solidFill>
          <a:latin typeface="+mn-lt"/>
          <a:ea typeface="+mn-ea"/>
          <a:cs typeface="+mn-cs"/>
        </a:defRPr>
      </a:lvl1pPr>
      <a:lvl2pPr marL="286482" algn="l" defTabSz="572963" rtl="0" eaLnBrk="1" latinLnBrk="0" hangingPunct="1">
        <a:defRPr sz="1128" kern="1200">
          <a:solidFill>
            <a:schemeClr val="tx1"/>
          </a:solidFill>
          <a:latin typeface="+mn-lt"/>
          <a:ea typeface="+mn-ea"/>
          <a:cs typeface="+mn-cs"/>
        </a:defRPr>
      </a:lvl2pPr>
      <a:lvl3pPr marL="572963" algn="l" defTabSz="572963" rtl="0" eaLnBrk="1" latinLnBrk="0" hangingPunct="1">
        <a:defRPr sz="1128" kern="1200">
          <a:solidFill>
            <a:schemeClr val="tx1"/>
          </a:solidFill>
          <a:latin typeface="+mn-lt"/>
          <a:ea typeface="+mn-ea"/>
          <a:cs typeface="+mn-cs"/>
        </a:defRPr>
      </a:lvl3pPr>
      <a:lvl4pPr marL="859445" algn="l" defTabSz="572963" rtl="0" eaLnBrk="1" latinLnBrk="0" hangingPunct="1">
        <a:defRPr sz="1128" kern="1200">
          <a:solidFill>
            <a:schemeClr val="tx1"/>
          </a:solidFill>
          <a:latin typeface="+mn-lt"/>
          <a:ea typeface="+mn-ea"/>
          <a:cs typeface="+mn-cs"/>
        </a:defRPr>
      </a:lvl4pPr>
      <a:lvl5pPr marL="1145926" algn="l" defTabSz="572963" rtl="0" eaLnBrk="1" latinLnBrk="0" hangingPunct="1">
        <a:defRPr sz="1128" kern="1200">
          <a:solidFill>
            <a:schemeClr val="tx1"/>
          </a:solidFill>
          <a:latin typeface="+mn-lt"/>
          <a:ea typeface="+mn-ea"/>
          <a:cs typeface="+mn-cs"/>
        </a:defRPr>
      </a:lvl5pPr>
      <a:lvl6pPr marL="1432408" algn="l" defTabSz="572963" rtl="0" eaLnBrk="1" latinLnBrk="0" hangingPunct="1">
        <a:defRPr sz="1128" kern="1200">
          <a:solidFill>
            <a:schemeClr val="tx1"/>
          </a:solidFill>
          <a:latin typeface="+mn-lt"/>
          <a:ea typeface="+mn-ea"/>
          <a:cs typeface="+mn-cs"/>
        </a:defRPr>
      </a:lvl6pPr>
      <a:lvl7pPr marL="1718889" algn="l" defTabSz="572963" rtl="0" eaLnBrk="1" latinLnBrk="0" hangingPunct="1">
        <a:defRPr sz="1128" kern="1200">
          <a:solidFill>
            <a:schemeClr val="tx1"/>
          </a:solidFill>
          <a:latin typeface="+mn-lt"/>
          <a:ea typeface="+mn-ea"/>
          <a:cs typeface="+mn-cs"/>
        </a:defRPr>
      </a:lvl7pPr>
      <a:lvl8pPr marL="2005371" algn="l" defTabSz="572963" rtl="0" eaLnBrk="1" latinLnBrk="0" hangingPunct="1">
        <a:defRPr sz="1128" kern="1200">
          <a:solidFill>
            <a:schemeClr val="tx1"/>
          </a:solidFill>
          <a:latin typeface="+mn-lt"/>
          <a:ea typeface="+mn-ea"/>
          <a:cs typeface="+mn-cs"/>
        </a:defRPr>
      </a:lvl8pPr>
      <a:lvl9pPr marL="2291852" algn="l" defTabSz="572963" rtl="0" eaLnBrk="1" latinLnBrk="0" hangingPunct="1">
        <a:defRPr sz="112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C2E5FD30-B2D9-46A3-9F94-E4F2F817157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98334104"/>
              </p:ext>
            </p:extLst>
          </p:nvPr>
        </p:nvGraphicFramePr>
        <p:xfrm>
          <a:off x="29371" y="48418"/>
          <a:ext cx="9267825" cy="42005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9930094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0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ierce, Ian</dc:creator>
  <cp:lastModifiedBy>Mike Nguyen</cp:lastModifiedBy>
  <cp:revision>5</cp:revision>
  <dcterms:created xsi:type="dcterms:W3CDTF">2019-04-27T02:50:38Z</dcterms:created>
  <dcterms:modified xsi:type="dcterms:W3CDTF">2020-03-14T07:20:06Z</dcterms:modified>
</cp:coreProperties>
</file>